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2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6002704"/>
            <a:ext cx="86409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210T88 as 4-hydroxyphénylacétylglycine (cas 28116-23-6)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tandar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d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/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6173" y="260648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173" y="2276872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6173" y="4149280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8</cp:revision>
  <dcterms:created xsi:type="dcterms:W3CDTF">2014-11-17T10:21:09Z</dcterms:created>
  <dcterms:modified xsi:type="dcterms:W3CDTF">2016-07-07T13:31:02Z</dcterms:modified>
</cp:coreProperties>
</file>